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5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 varScale="1">
        <p:scale>
          <a:sx n="59" d="100"/>
          <a:sy n="59" d="100"/>
        </p:scale>
        <p:origin x="2892" y="7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558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247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66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833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082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007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072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941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327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74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773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35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2402" y="363852"/>
            <a:ext cx="683200" cy="2959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</a:t>
            </a:r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S6</a:t>
            </a:r>
            <a:endParaRPr lang="en-US" altLang="zh-CN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24" t="4771" r="20196" b="6732"/>
          <a:stretch/>
        </p:blipFill>
        <p:spPr>
          <a:xfrm>
            <a:off x="2742119" y="1520433"/>
            <a:ext cx="3313235" cy="4313578"/>
          </a:xfrm>
          <a:prstGeom prst="rect">
            <a:avLst/>
          </a:prstGeom>
        </p:spPr>
      </p:pic>
      <p:sp>
        <p:nvSpPr>
          <p:cNvPr id="6" name="文本框 48"/>
          <p:cNvSpPr txBox="1"/>
          <p:nvPr/>
        </p:nvSpPr>
        <p:spPr>
          <a:xfrm>
            <a:off x="3637880" y="5893689"/>
            <a:ext cx="125256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lang="en-US" altLang="zh-CN" sz="132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value</a:t>
            </a:r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835694" y="5746882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26"/>
          <p:cNvSpPr txBox="1"/>
          <p:nvPr/>
        </p:nvSpPr>
        <p:spPr>
          <a:xfrm>
            <a:off x="3637880" y="5745876"/>
            <a:ext cx="2812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26"/>
          <p:cNvSpPr txBox="1"/>
          <p:nvPr/>
        </p:nvSpPr>
        <p:spPr>
          <a:xfrm>
            <a:off x="4444779" y="5753125"/>
            <a:ext cx="29237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26"/>
          <p:cNvSpPr txBox="1"/>
          <p:nvPr/>
        </p:nvSpPr>
        <p:spPr>
          <a:xfrm>
            <a:off x="5256508" y="5747932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951866" y="3343988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937025" y="3533718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48"/>
          <p:cNvSpPr txBox="1"/>
          <p:nvPr/>
        </p:nvSpPr>
        <p:spPr>
          <a:xfrm>
            <a:off x="5951849" y="3715749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function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48"/>
          <p:cNvSpPr txBox="1"/>
          <p:nvPr/>
        </p:nvSpPr>
        <p:spPr>
          <a:xfrm>
            <a:off x="3105356" y="1296335"/>
            <a:ext cx="2648440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ost enriched GO terms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696240" y="1559316"/>
            <a:ext cx="222749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ranscription, DNA-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mplated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46547" y="2179816"/>
            <a:ext cx="283325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nase C-activating G-protein coupled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ptor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933035" y="1973559"/>
            <a:ext cx="174684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sal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832964" y="1760754"/>
            <a:ext cx="208050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ition metal ion homeosta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318170" y="2385385"/>
            <a:ext cx="174684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water depriva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836965" y="3217315"/>
            <a:ext cx="174684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auxi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808965" y="2593491"/>
            <a:ext cx="107572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846925" y="2806068"/>
            <a:ext cx="207687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auxin biosynthet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693813" y="3016459"/>
            <a:ext cx="131398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gni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olle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354895" y="3425735"/>
            <a:ext cx="174684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-embryonic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elopmen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260954" y="3627827"/>
            <a:ext cx="174684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leaf developmen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25995" y="4251270"/>
            <a:ext cx="276240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smonic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mediated signaling pathwa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2298313" y="4468600"/>
            <a:ext cx="68485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887964" y="3838486"/>
            <a:ext cx="104194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e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65989" y="4064253"/>
            <a:ext cx="265781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ongation from RNA polymerase II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482254" y="4665796"/>
            <a:ext cx="247385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-specific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binding transcrip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324092" y="4874384"/>
            <a:ext cx="156060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acylglycerol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n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2012628" y="5079334"/>
            <a:ext cx="94528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a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394890" y="5296033"/>
            <a:ext cx="150750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i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l ion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058097" y="5507983"/>
            <a:ext cx="194712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phosphogluconolacton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5227675" y="1565635"/>
            <a:ext cx="35184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3843523" y="1774753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737976" y="1980558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690867" y="2201732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691654" y="2400538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3628766" y="2615615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3576790" y="2811906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459275" y="3026862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418480" y="3230152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368641" y="3441604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340642" y="3651595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3257563" y="3861367"/>
            <a:ext cx="32032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299461" y="4057988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3283725" y="4274931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4229596" y="4491419"/>
            <a:ext cx="34053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606419" y="4691183"/>
            <a:ext cx="34053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656765" y="4904439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537907" y="5113823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537907" y="5311106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537637" y="5528491"/>
            <a:ext cx="2661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3577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118</Words>
  <Application>Microsoft Office PowerPoint</Application>
  <PresentationFormat>自定义</PresentationFormat>
  <Paragraphs>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44:31Z</dcterms:modified>
</cp:coreProperties>
</file>